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2" autoAdjust="0"/>
    <p:restoredTop sz="94660"/>
  </p:normalViewPr>
  <p:slideViewPr>
    <p:cSldViewPr snapToGrid="0">
      <p:cViewPr varScale="1">
        <p:scale>
          <a:sx n="72" d="100"/>
          <a:sy n="72" d="100"/>
        </p:scale>
        <p:origin x="240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D7155-9447-41E1-A0BA-9C32198F453A}" type="datetimeFigureOut">
              <a:rPr lang="fr-FR" smtClean="0"/>
              <a:t>02/07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8F5C6-6DB4-4FBA-9DF4-3F13F02B84C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410511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D7155-9447-41E1-A0BA-9C32198F453A}" type="datetimeFigureOut">
              <a:rPr lang="fr-FR" smtClean="0"/>
              <a:t>02/07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8F5C6-6DB4-4FBA-9DF4-3F13F02B84C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27132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D7155-9447-41E1-A0BA-9C32198F453A}" type="datetimeFigureOut">
              <a:rPr lang="fr-FR" smtClean="0"/>
              <a:t>02/07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8F5C6-6DB4-4FBA-9DF4-3F13F02B84C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38438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D7155-9447-41E1-A0BA-9C32198F453A}" type="datetimeFigureOut">
              <a:rPr lang="fr-FR" smtClean="0"/>
              <a:t>02/07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8F5C6-6DB4-4FBA-9DF4-3F13F02B84C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085893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D7155-9447-41E1-A0BA-9C32198F453A}" type="datetimeFigureOut">
              <a:rPr lang="fr-FR" smtClean="0"/>
              <a:t>02/07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8F5C6-6DB4-4FBA-9DF4-3F13F02B84C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419879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D7155-9447-41E1-A0BA-9C32198F453A}" type="datetimeFigureOut">
              <a:rPr lang="fr-FR" smtClean="0"/>
              <a:t>02/07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8F5C6-6DB4-4FBA-9DF4-3F13F02B84C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844679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D7155-9447-41E1-A0BA-9C32198F453A}" type="datetimeFigureOut">
              <a:rPr lang="fr-FR" smtClean="0"/>
              <a:t>02/07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8F5C6-6DB4-4FBA-9DF4-3F13F02B84C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175383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D7155-9447-41E1-A0BA-9C32198F453A}" type="datetimeFigureOut">
              <a:rPr lang="fr-FR" smtClean="0"/>
              <a:t>02/07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8F5C6-6DB4-4FBA-9DF4-3F13F02B84C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086193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D7155-9447-41E1-A0BA-9C32198F453A}" type="datetimeFigureOut">
              <a:rPr lang="fr-FR" smtClean="0"/>
              <a:t>02/07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8F5C6-6DB4-4FBA-9DF4-3F13F02B84C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222541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D7155-9447-41E1-A0BA-9C32198F453A}" type="datetimeFigureOut">
              <a:rPr lang="fr-FR" smtClean="0"/>
              <a:t>02/07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8F5C6-6DB4-4FBA-9DF4-3F13F02B84C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969526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D7155-9447-41E1-A0BA-9C32198F453A}" type="datetimeFigureOut">
              <a:rPr lang="fr-FR" smtClean="0"/>
              <a:t>02/07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8F5C6-6DB4-4FBA-9DF4-3F13F02B84C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533037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ED7155-9447-41E1-A0BA-9C32198F453A}" type="datetimeFigureOut">
              <a:rPr lang="fr-FR" smtClean="0"/>
              <a:t>02/07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98F5C6-6DB4-4FBA-9DF4-3F13F02B84C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073743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2274" y="2094532"/>
            <a:ext cx="2915443" cy="1943629"/>
          </a:xfrm>
          <a:prstGeom prst="rect">
            <a:avLst/>
          </a:prstGeom>
        </p:spPr>
      </p:pic>
      <p:sp>
        <p:nvSpPr>
          <p:cNvPr id="2" name="ZoneTexte 1"/>
          <p:cNvSpPr txBox="1"/>
          <p:nvPr/>
        </p:nvSpPr>
        <p:spPr>
          <a:xfrm>
            <a:off x="3128386" y="6461886"/>
            <a:ext cx="211917" cy="2362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35" dirty="0"/>
              <a:t> </a:t>
            </a:r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18914" y="2094533"/>
            <a:ext cx="2915447" cy="1943630"/>
          </a:xfrm>
          <a:prstGeom prst="rect">
            <a:avLst/>
          </a:prstGeom>
        </p:spPr>
      </p:pic>
      <p:sp>
        <p:nvSpPr>
          <p:cNvPr id="3" name="ZoneTexte 2"/>
          <p:cNvSpPr txBox="1"/>
          <p:nvPr/>
        </p:nvSpPr>
        <p:spPr>
          <a:xfrm>
            <a:off x="894003" y="1874506"/>
            <a:ext cx="277640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46" dirty="0"/>
              <a:t>A</a:t>
            </a:r>
          </a:p>
        </p:txBody>
      </p:sp>
      <p:sp>
        <p:nvSpPr>
          <p:cNvPr id="6" name="ZoneTexte 5"/>
          <p:cNvSpPr txBox="1"/>
          <p:nvPr/>
        </p:nvSpPr>
        <p:spPr>
          <a:xfrm>
            <a:off x="3809446" y="1874506"/>
            <a:ext cx="271228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46" dirty="0"/>
              <a:t>B</a:t>
            </a:r>
          </a:p>
        </p:txBody>
      </p:sp>
      <p:sp>
        <p:nvSpPr>
          <p:cNvPr id="7" name="Rectangle 6"/>
          <p:cNvSpPr/>
          <p:nvPr/>
        </p:nvSpPr>
        <p:spPr>
          <a:xfrm>
            <a:off x="682274" y="5039647"/>
            <a:ext cx="5682595" cy="41549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3</a:t>
            </a:r>
            <a:endParaRPr lang="fr-FR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Βeta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diversity analysis. Multidimensional scaling (MDS) of the Bray-Curtis pairwise dissimilarity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trice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between Fischer and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ong-Evans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ats treated or not with probiotic (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</a:t>
            </a:r>
            <a:r>
              <a:rPr lang="en-US" sz="1200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68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= 42.42, </a:t>
            </a:r>
            <a:r>
              <a:rPr lang="en-US" sz="1200" i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0.0001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Each lineage label is positioned at the center of the corresponding samples. Ellipses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ere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rawn around each lineage by fitting a bivariate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aussian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o the cloud of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amples.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Beta-diversity analysis.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DS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the Bray-Curtis pairwise dissimilarity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trix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etween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ternally deprived Long-Evans rats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lone)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r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ot maternally deprived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</a:t>
            </a:r>
            <a:r>
              <a:rPr lang="en-US" sz="1200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44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= 2.97, </a:t>
            </a:r>
            <a:r>
              <a:rPr lang="en-US" sz="1200" i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0.0006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Each lineage label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as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ositioned at the center of the corresponding samples. </a:t>
            </a:r>
            <a:r>
              <a:rPr lang="en-US" sz="120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llipses </a:t>
            </a:r>
            <a:r>
              <a:rPr lang="en-US" sz="120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ere</a:t>
            </a:r>
            <a:r>
              <a:rPr lang="en-US" sz="120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rawn around each lineage by fitting a bivariate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aussian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o the cloud of samples and computing its 95% confidence ellipse. Axes are labelled by the fraction of dissimilarity they explain.</a:t>
            </a:r>
            <a:endParaRPr lang="fr-FR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68784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</TotalTime>
  <Words>147</Words>
  <Application>Microsoft Office PowerPoint</Application>
  <PresentationFormat>Format A4 (210 x 297 mm)</PresentationFormat>
  <Paragraphs>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inr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Valerie Dauge</dc:creator>
  <cp:lastModifiedBy>Valerie Dauge</cp:lastModifiedBy>
  <cp:revision>17</cp:revision>
  <dcterms:created xsi:type="dcterms:W3CDTF">2018-11-06T09:00:08Z</dcterms:created>
  <dcterms:modified xsi:type="dcterms:W3CDTF">2020-07-02T08:27:32Z</dcterms:modified>
</cp:coreProperties>
</file>